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7" d="100"/>
          <a:sy n="117" d="100"/>
        </p:scale>
        <p:origin x="298" y="224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24DFB-44C1-4F62-8428-6BD7928B9F31}" type="datetimeFigureOut">
              <a:rPr lang="fr-FR" smtClean="0"/>
              <a:t>11/05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1F365-FCA8-47E8-845C-76766E750E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0911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24DFB-44C1-4F62-8428-6BD7928B9F31}" type="datetimeFigureOut">
              <a:rPr lang="fr-FR" smtClean="0"/>
              <a:t>11/05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1F365-FCA8-47E8-845C-76766E750E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3221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24DFB-44C1-4F62-8428-6BD7928B9F31}" type="datetimeFigureOut">
              <a:rPr lang="fr-FR" smtClean="0"/>
              <a:t>11/05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1F365-FCA8-47E8-845C-76766E750E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3296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24DFB-44C1-4F62-8428-6BD7928B9F31}" type="datetimeFigureOut">
              <a:rPr lang="fr-FR" smtClean="0"/>
              <a:t>11/05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1F365-FCA8-47E8-845C-76766E750E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0799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24DFB-44C1-4F62-8428-6BD7928B9F31}" type="datetimeFigureOut">
              <a:rPr lang="fr-FR" smtClean="0"/>
              <a:t>11/05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1F365-FCA8-47E8-845C-76766E750E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2679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24DFB-44C1-4F62-8428-6BD7928B9F31}" type="datetimeFigureOut">
              <a:rPr lang="fr-FR" smtClean="0"/>
              <a:t>11/05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1F365-FCA8-47E8-845C-76766E750E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77420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24DFB-44C1-4F62-8428-6BD7928B9F31}" type="datetimeFigureOut">
              <a:rPr lang="fr-FR" smtClean="0"/>
              <a:t>11/05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1F365-FCA8-47E8-845C-76766E750E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9511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24DFB-44C1-4F62-8428-6BD7928B9F31}" type="datetimeFigureOut">
              <a:rPr lang="fr-FR" smtClean="0"/>
              <a:t>11/05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1F365-FCA8-47E8-845C-76766E750E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534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24DFB-44C1-4F62-8428-6BD7928B9F31}" type="datetimeFigureOut">
              <a:rPr lang="fr-FR" smtClean="0"/>
              <a:t>11/05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1F365-FCA8-47E8-845C-76766E750E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6762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24DFB-44C1-4F62-8428-6BD7928B9F31}" type="datetimeFigureOut">
              <a:rPr lang="fr-FR" smtClean="0"/>
              <a:t>11/05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1F365-FCA8-47E8-845C-76766E750E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63066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24DFB-44C1-4F62-8428-6BD7928B9F31}" type="datetimeFigureOut">
              <a:rPr lang="fr-FR" smtClean="0"/>
              <a:t>11/05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1F365-FCA8-47E8-845C-76766E750E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7544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D24DFB-44C1-4F62-8428-6BD7928B9F31}" type="datetimeFigureOut">
              <a:rPr lang="fr-FR" smtClean="0"/>
              <a:t>11/05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51F365-FCA8-47E8-845C-76766E750E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3274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pseite\Desktop\PLOS ONE\blot PC3 revision 2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5232" y="2792760"/>
            <a:ext cx="3907536" cy="29992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ZoneTexte 3"/>
          <p:cNvSpPr txBox="1"/>
          <p:nvPr/>
        </p:nvSpPr>
        <p:spPr>
          <a:xfrm>
            <a:off x="404664" y="560512"/>
            <a:ext cx="7889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_Fig</a:t>
            </a:r>
            <a:endParaRPr lang="fr-FR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764705" y="6537176"/>
            <a:ext cx="5832648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al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the nuclear ErbB3</a:t>
            </a:r>
            <a:r>
              <a:rPr lang="en-US" sz="1400" b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0kDa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soform at the protein level.</a:t>
            </a: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3 cells were transiently transfected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trol,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ErbB3A o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ErbB3B 48h before cytosolic (C) and nuclear (N) extraction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estern blotting was performed using antibodies to PPIG (sc-100699, SCBT), GATA2 (sc-9008, SCBT), RUNX2 (sc-10758, SCBT), CCND1 (#2922, CST) or histone H3 (#2650, CST) as a control for nuclear extraction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636974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84</Words>
  <Application>Microsoft Office PowerPoint</Application>
  <PresentationFormat>Format A4 (210 x 297 mm)</PresentationFormat>
  <Paragraphs>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seite</dc:creator>
  <cp:lastModifiedBy>pseite</cp:lastModifiedBy>
  <cp:revision>6</cp:revision>
  <dcterms:created xsi:type="dcterms:W3CDTF">2016-05-02T12:51:42Z</dcterms:created>
  <dcterms:modified xsi:type="dcterms:W3CDTF">2016-05-11T07:18:07Z</dcterms:modified>
</cp:coreProperties>
</file>